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HCV_hospitalizations_updated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Yearly rate of HCV-specific hospitalizations</a:t>
            </a:r>
            <a:r>
              <a:rPr lang="en-US" baseline="0"/>
              <a:t> with HCC per 1,000,000 of Canadian population, by sex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Sex!$J$1</c:f>
              <c:strCache>
                <c:ptCount val="1"/>
                <c:pt idx="0">
                  <c:v>Female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Sex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Sex!$J$2:$J$15</c:f>
              <c:numCache>
                <c:formatCode>General</c:formatCode>
                <c:ptCount val="14"/>
                <c:pt idx="0">
                  <c:v>7.6096945072920663</c:v>
                </c:pt>
                <c:pt idx="1">
                  <c:v>6.9318143939788932</c:v>
                </c:pt>
                <c:pt idx="2">
                  <c:v>6.6178022457601351</c:v>
                </c:pt>
                <c:pt idx="3">
                  <c:v>8.7235953567366966</c:v>
                </c:pt>
                <c:pt idx="4">
                  <c:v>10.374734234862768</c:v>
                </c:pt>
                <c:pt idx="5">
                  <c:v>11.082379017362394</c:v>
                </c:pt>
                <c:pt idx="6">
                  <c:v>11.711393334743271</c:v>
                </c:pt>
                <c:pt idx="7">
                  <c:v>12.215958464383892</c:v>
                </c:pt>
                <c:pt idx="8">
                  <c:v>11.032867977789548</c:v>
                </c:pt>
                <c:pt idx="9">
                  <c:v>9.6163963894155842</c:v>
                </c:pt>
                <c:pt idx="10">
                  <c:v>9.6190890217007201</c:v>
                </c:pt>
                <c:pt idx="11">
                  <c:v>7.116065969299445</c:v>
                </c:pt>
                <c:pt idx="12">
                  <c:v>8.4142602954102088</c:v>
                </c:pt>
                <c:pt idx="13">
                  <c:v>6.71300401379495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33D-413C-8236-FE6579743F5A}"/>
            </c:ext>
          </c:extLst>
        </c:ser>
        <c:ser>
          <c:idx val="2"/>
          <c:order val="1"/>
          <c:tx>
            <c:strRef>
              <c:f>Sex!$K$1</c:f>
              <c:strCache>
                <c:ptCount val="1"/>
                <c:pt idx="0">
                  <c:v>Male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Sex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Sex!$K$2:$K$15</c:f>
              <c:numCache>
                <c:formatCode>General</c:formatCode>
                <c:ptCount val="14"/>
                <c:pt idx="0">
                  <c:v>23.475110405797942</c:v>
                </c:pt>
                <c:pt idx="1">
                  <c:v>26.99576632759166</c:v>
                </c:pt>
                <c:pt idx="2">
                  <c:v>27.922485722808144</c:v>
                </c:pt>
                <c:pt idx="3">
                  <c:v>35.826994145797144</c:v>
                </c:pt>
                <c:pt idx="4">
                  <c:v>36.087748547690701</c:v>
                </c:pt>
                <c:pt idx="5">
                  <c:v>38.437739795073952</c:v>
                </c:pt>
                <c:pt idx="6">
                  <c:v>37.071685483355509</c:v>
                </c:pt>
                <c:pt idx="7">
                  <c:v>46.14633560454142</c:v>
                </c:pt>
                <c:pt idx="8">
                  <c:v>41.918592954934894</c:v>
                </c:pt>
                <c:pt idx="9">
                  <c:v>45.221532156320173</c:v>
                </c:pt>
                <c:pt idx="10">
                  <c:v>42.921339083267171</c:v>
                </c:pt>
                <c:pt idx="11">
                  <c:v>32.035397956836356</c:v>
                </c:pt>
                <c:pt idx="12">
                  <c:v>31.022014003478379</c:v>
                </c:pt>
                <c:pt idx="13">
                  <c:v>25.2104551129452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33D-413C-8236-FE6579743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22278991"/>
        <c:axId val="2049805903"/>
      </c:lineChart>
      <c:catAx>
        <c:axId val="2222789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9805903"/>
        <c:crosses val="autoZero"/>
        <c:auto val="1"/>
        <c:lblAlgn val="ctr"/>
        <c:lblOffset val="100"/>
        <c:noMultiLvlLbl val="0"/>
      </c:catAx>
      <c:valAx>
        <c:axId val="2049805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22789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43F23-1120-257C-5A23-8A9597E359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176C31-E62C-56E5-BC67-EAC3C6244F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EE0D2E-3BC6-D9D6-1E56-318080D761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0B4B45-DFBD-2919-F9DC-E5AB9C450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4660FE-C87B-0408-A740-3BECA3713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710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4E1939-7B6F-DA90-D13A-45CA76F3EA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A60324-8688-346E-9EBA-CF9A157533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5A72C7-947E-E669-1FAB-651B48339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6ED8F4-A0A8-4C70-B10B-1709FACE7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D862E5-124D-7B29-2A4A-6675B2E86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20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2F20055-0586-79F3-DF2A-3DBF738EA0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9CE67C-C619-59CA-58F5-7290DCFE3E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A9659D-3286-C18B-BF06-E8C697695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90FC88-3481-BF30-7078-C65BD3FED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2F15A8-1217-5658-D140-B4A1578C4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323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102A65-06B0-45C8-1C5C-05B31E498D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61A80E-5E71-EF71-190D-6044A136B3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F7E56D-B4B5-2F8D-0074-C98F9508C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3424B-9A2C-C598-E7C5-FF49D5930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B6272E-6A70-B4C6-65FC-349307FE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765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11436-DD2D-4343-F13C-7EA5A786C4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D401C7-8661-D44C-873D-0A8F09D88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70A8F4-7B1F-9E9B-6104-22D4FA730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97094C-792B-8D57-8EEC-783941AD5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9AB0F-D6BA-DE2B-CDC6-A86D77E40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909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EABAB-ADA9-4210-E513-7AC44CC32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3C17C9-6A89-7AF9-F559-871A445DCE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9C9071-BD5F-781D-62B1-B6B9D3A2A7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FE732B-8C1E-3DC2-BCA8-F2AFDEA21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AFB63A-3761-63CC-900C-8E217C263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FFE411-7471-2898-F76A-110724D60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70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55F4B8-56AC-87E7-3A2A-37661C3D6D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C1BE6D-905E-76C7-2DE3-67494C756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618DAC-DE51-4546-D9D9-93B6426F60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BFC673-0CCB-D9F8-0A8E-6884308F59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B55D39-7B59-9801-BAB7-5AE69E4765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5C3C1-070D-5F34-F5FE-1BB06C646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E9F628-1BDD-31F2-1D7E-602936F35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AF0E70-1282-4730-73D8-76F382BC7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60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B3018-CF41-DD59-703B-42F5DDCC56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418A66-ACDF-370D-4CAE-8DD66FEFD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579AF4-6772-FEBD-75B9-B802DA51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A5450-666E-5734-149D-9934EAAC0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539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F496D6-050F-014C-2D12-83F907658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EEE600-8086-62C4-DD0D-61A7C94B7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AADB6E-7F6A-9DDB-683E-E46D29588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572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BF6C9-12F6-AFBD-71A4-20B115BE86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77CA6-B8E6-F282-BC65-8B1E862EA7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7A2563-E258-2CB8-F45D-B66B1D91F5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90E8CB-14B4-93DB-319A-D0F104EB7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0C9907-3403-BF79-13DE-0A9D28C0A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A6D8ED-CE6A-6535-8FF6-5F8E6C36A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153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5A251-8473-7F9C-A6D8-D3927A52B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95890E-30C2-0286-AD48-68F3A89F51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942022-1B81-E605-9B6F-3DB79B20C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F9F29D-64AD-4F88-CB26-3C7752116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CD0BDB-BDCB-FD79-AFED-031F01CEE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B11C79-240B-1C28-72A1-6D489A064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746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1842A0-A384-3F54-4B67-CE935C774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EB7B43-B1F2-A2FE-08C0-3193068E31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44E433-4778-93A2-F2BD-40AAD1C69F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0CEC98-F44B-4F69-BA21-4E364B145F3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B1909F-889E-C18A-4A42-495B90455A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ECE5B-B22F-A8F0-512C-886A08FD7B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988A1-AF72-4CC5-A92B-A0DBEBC51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317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9729F48-DFB5-479B-A1E8-37F966678DC2}"/>
              </a:ext>
            </a:extLst>
          </p:cNvPr>
          <p:cNvGraphicFramePr>
            <a:graphicFrameLocks/>
          </p:cNvGraphicFramePr>
          <p:nvPr/>
        </p:nvGraphicFramePr>
        <p:xfrm>
          <a:off x="1472105" y="1221130"/>
          <a:ext cx="9010544" cy="44135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7078363" y="1709351"/>
            <a:ext cx="0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8849498" y="1709351"/>
            <a:ext cx="0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12467277-9B19-7C67-341E-C4F37B794F4B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4 Figure</a:t>
            </a:r>
          </a:p>
        </p:txBody>
      </p:sp>
    </p:spTree>
    <p:extLst>
      <p:ext uri="{BB962C8B-B14F-4D97-AF65-F5344CB8AC3E}">
        <p14:creationId xmlns:p14="http://schemas.microsoft.com/office/powerpoint/2010/main" val="2500260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omen's College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3-07-26T15:47:04Z</dcterms:created>
  <dcterms:modified xsi:type="dcterms:W3CDTF">2023-07-26T15:47:17Z</dcterms:modified>
</cp:coreProperties>
</file>